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682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967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624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752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9692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6455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021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3195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355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257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86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5344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5E8D3-53B4-4B7C-A382-2F845BBFD157}" type="datetimeFigureOut">
              <a:rPr lang="zh-CN" altLang="en-US" smtClean="0"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46DC8-4B47-4087-B1D2-3F0FF645DF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9819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4414497" y="815756"/>
            <a:ext cx="2880000" cy="2880000"/>
            <a:chOff x="4157811" y="1543491"/>
            <a:chExt cx="2880000" cy="2880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9" r="1489" b="2979"/>
            <a:stretch/>
          </p:blipFill>
          <p:spPr>
            <a:xfrm>
              <a:off x="4157811" y="1543491"/>
              <a:ext cx="2880000" cy="2880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64" t="41967" r="57738" b="36852"/>
            <a:stretch/>
          </p:blipFill>
          <p:spPr>
            <a:xfrm>
              <a:off x="5963714" y="1553081"/>
              <a:ext cx="1074097" cy="720000"/>
            </a:xfrm>
            <a:prstGeom prst="rect">
              <a:avLst/>
            </a:prstGeom>
            <a:ln w="25400">
              <a:solidFill>
                <a:schemeClr val="bg1"/>
              </a:solidFill>
            </a:ln>
          </p:spPr>
        </p:pic>
        <p:sp>
          <p:nvSpPr>
            <p:cNvPr id="13" name="矩形 12"/>
            <p:cNvSpPr/>
            <p:nvPr/>
          </p:nvSpPr>
          <p:spPr>
            <a:xfrm>
              <a:off x="4688654" y="2709988"/>
              <a:ext cx="724509" cy="463138"/>
            </a:xfrm>
            <a:prstGeom prst="rect">
              <a:avLst/>
            </a:prstGeom>
            <a:noFill/>
            <a:ln w="254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7557712" y="815756"/>
            <a:ext cx="2880000" cy="2880000"/>
            <a:chOff x="7253578" y="1501556"/>
            <a:chExt cx="2880000" cy="2880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4" r="1324" b="2648"/>
            <a:stretch/>
          </p:blipFill>
          <p:spPr>
            <a:xfrm>
              <a:off x="7253578" y="1501556"/>
              <a:ext cx="2880000" cy="2880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91" t="42189" r="57811" b="36803"/>
            <a:stretch/>
          </p:blipFill>
          <p:spPr>
            <a:xfrm>
              <a:off x="9031714" y="1505816"/>
              <a:ext cx="1082975" cy="720000"/>
            </a:xfrm>
            <a:prstGeom prst="rect">
              <a:avLst/>
            </a:prstGeom>
            <a:ln w="25400">
              <a:solidFill>
                <a:schemeClr val="bg1"/>
              </a:solidFill>
            </a:ln>
          </p:spPr>
        </p:pic>
        <p:sp>
          <p:nvSpPr>
            <p:cNvPr id="16" name="矩形 15"/>
            <p:cNvSpPr/>
            <p:nvPr/>
          </p:nvSpPr>
          <p:spPr>
            <a:xfrm>
              <a:off x="7818108" y="2799130"/>
              <a:ext cx="724509" cy="463138"/>
            </a:xfrm>
            <a:prstGeom prst="rect">
              <a:avLst/>
            </a:prstGeom>
            <a:noFill/>
            <a:ln w="254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1271282" y="825346"/>
            <a:ext cx="2880000" cy="2880000"/>
            <a:chOff x="1112646" y="1516065"/>
            <a:chExt cx="2880000" cy="2880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" r="1741" b="3482"/>
            <a:stretch/>
          </p:blipFill>
          <p:spPr>
            <a:xfrm>
              <a:off x="1112646" y="1516065"/>
              <a:ext cx="2880000" cy="288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78" t="42140" r="26224" b="36853"/>
            <a:stretch/>
          </p:blipFill>
          <p:spPr>
            <a:xfrm>
              <a:off x="2909671" y="1516065"/>
              <a:ext cx="1082975" cy="720000"/>
            </a:xfrm>
            <a:prstGeom prst="rect">
              <a:avLst/>
            </a:prstGeom>
            <a:ln w="25400">
              <a:solidFill>
                <a:schemeClr val="bg1"/>
              </a:solidFill>
            </a:ln>
          </p:spPr>
        </p:pic>
        <p:sp>
          <p:nvSpPr>
            <p:cNvPr id="9" name="矩形 8"/>
            <p:cNvSpPr/>
            <p:nvPr/>
          </p:nvSpPr>
          <p:spPr>
            <a:xfrm>
              <a:off x="2273455" y="2703279"/>
              <a:ext cx="724509" cy="463138"/>
            </a:xfrm>
            <a:prstGeom prst="rect">
              <a:avLst/>
            </a:prstGeom>
            <a:noFill/>
            <a:ln w="2540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6" name="直接连接符 5"/>
            <p:cNvCxnSpPr/>
            <p:nvPr/>
          </p:nvCxnSpPr>
          <p:spPr>
            <a:xfrm flipV="1">
              <a:off x="3581400" y="4257675"/>
              <a:ext cx="324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文本框 19"/>
          <p:cNvSpPr txBox="1"/>
          <p:nvPr/>
        </p:nvSpPr>
        <p:spPr>
          <a:xfrm>
            <a:off x="2307560" y="400050"/>
            <a:ext cx="1114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83819" y="400050"/>
            <a:ext cx="1056704" cy="3758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8564573" y="400050"/>
            <a:ext cx="108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RNA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6200000">
            <a:off x="121993" y="2013768"/>
            <a:ext cx="14382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67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20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2000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999168" y="4531485"/>
            <a:ext cx="1037368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4: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ce staining of Ki67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complet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-epithelializatio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two weeks. Scale bars=20</a:t>
            </a:r>
            <a:r>
              <a:rPr lang="el-GR" altLang="zh-CN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934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3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j</dc:creator>
  <cp:lastModifiedBy>jun xiao</cp:lastModifiedBy>
  <cp:revision>19</cp:revision>
  <dcterms:created xsi:type="dcterms:W3CDTF">2017-12-14T01:22:43Z</dcterms:created>
  <dcterms:modified xsi:type="dcterms:W3CDTF">2017-12-18T13:37:49Z</dcterms:modified>
</cp:coreProperties>
</file>